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08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74C43-40AD-4A7E-9253-DB82BE56832B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E3BF1A-4F2C-4580-81A1-FE4206B4D2F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hilip.roberts@ucr.edu" TargetMode="External"/><Relationship Id="rId2" Type="http://schemas.openxmlformats.org/officeDocument/2006/relationships/hyperlink" Target="mailto:timothy.close@ucr.ed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914400" y="1600200"/>
            <a:ext cx="7166449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tic Mapping, Synteny and Physical Location of Two Loci for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usarium oxyspor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f.sp.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acheiphil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ce 4 Resistance in Cowpea [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ig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guiculat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L.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lp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olecular Breedin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uthors and Affiliations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rti O. Pottorff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uoj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Jeffery D. Ehler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,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Timothy J. Close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Philip A. Robert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Botany &amp; Plant Sciences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Zhejiang Academy of Agricultural Sciences, Hangzhou, P.R. Chin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ill &amp; Melinda Gates Foundation, Seattle, Washington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Nematology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sponding author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timothy.close@ucr.edu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3"/>
              </a:rPr>
              <a:t>philip.roberts@ucr.edu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1524000" y="2404125"/>
          <a:ext cx="6095999" cy="2049750"/>
        </p:xfrm>
        <a:graphic>
          <a:graphicData uri="http://schemas.openxmlformats.org/drawingml/2006/table">
            <a:tbl>
              <a:tblPr/>
              <a:tblGrid>
                <a:gridCol w="521512"/>
                <a:gridCol w="885003"/>
                <a:gridCol w="652303"/>
                <a:gridCol w="383708"/>
                <a:gridCol w="377931"/>
                <a:gridCol w="377931"/>
                <a:gridCol w="377931"/>
                <a:gridCol w="377931"/>
                <a:gridCol w="377931"/>
                <a:gridCol w="377931"/>
                <a:gridCol w="344512"/>
                <a:gridCol w="344512"/>
                <a:gridCol w="344512"/>
                <a:gridCol w="352351"/>
              </a:tblGrid>
              <a:tr h="113875">
                <a:tc gridSpan="14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nline Resource 5. QTL analysis of </a:t>
                      </a:r>
                      <a:r>
                        <a:rPr lang="en-US" sz="600" i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Fot4-2</a:t>
                      </a: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in the CB27 x 24-125B-1 population.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Experiment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henotype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QTL analysis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0400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0604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013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095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08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108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136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0984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0380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116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_0594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00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Wilt/stunting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QM LOD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7.6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Wilt/stunting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</a:t>
                      </a:r>
                      <a:r>
                        <a:rPr lang="en-US" sz="600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 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7.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Wilt/stunting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KW 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2.5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1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1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1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1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1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1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1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1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1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40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Wilt/stunting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-value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Vascular discoloration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QM LOD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1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1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1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1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1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1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1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1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18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8.4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Vascular discoloration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</a:t>
                      </a:r>
                      <a:r>
                        <a:rPr lang="en-US" sz="600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 </a:t>
                      </a: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9.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40.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Vascular discoloration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KW 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3.7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.9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.9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.9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.9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.99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.9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.9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.9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.9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8.5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Vascular discoloration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-value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00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Wilt/stunting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QM LOD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5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5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5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5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5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5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5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8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8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8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Wilt/stunting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</a:t>
                      </a:r>
                      <a:r>
                        <a:rPr lang="en-US" sz="600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0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0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0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0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0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0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0.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2.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2.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2.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28.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Wilt/stunting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KW 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10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3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3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3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3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3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3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90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90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90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.0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Wilt/stunting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-value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Vascular discoloration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QM LOD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7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7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7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7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7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7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73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4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4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4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.44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Vascular discoloration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</a:t>
                      </a:r>
                      <a:r>
                        <a:rPr lang="en-US" sz="600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1.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1.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1.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1.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1.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1.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1.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5.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5.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35.6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  <a:cs typeface="Times New Roman"/>
                        </a:rPr>
                        <a:t>29.7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Vascular discoloration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KW 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40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3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5.2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5.2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5.2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09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8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7448" marR="4744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Vascular discoloration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-value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7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7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448" marR="4744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4</Words>
  <Application>Microsoft Office PowerPoint</Application>
  <PresentationFormat>On-screen Show (4:3)</PresentationFormat>
  <Paragraphs>23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ti</dc:creator>
  <cp:lastModifiedBy>Marti</cp:lastModifiedBy>
  <cp:revision>1</cp:revision>
  <dcterms:created xsi:type="dcterms:W3CDTF">2013-11-13T12:22:23Z</dcterms:created>
  <dcterms:modified xsi:type="dcterms:W3CDTF">2013-11-13T12:23:19Z</dcterms:modified>
</cp:coreProperties>
</file>